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42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37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6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73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15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4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5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568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2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8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1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25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F744FB5-9D41-4021-BFC2-DBDDD51882C0}"/>
              </a:ext>
            </a:extLst>
          </p:cNvPr>
          <p:cNvSpPr txBox="1"/>
          <p:nvPr/>
        </p:nvSpPr>
        <p:spPr>
          <a:xfrm>
            <a:off x="192251" y="7907326"/>
            <a:ext cx="650000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forms of recombination in the UL sub-region involving the J-1 and 814 strains. (A) The recombination of J-1 with North American, European, and Asian strains. (B) The recombination of J-1 with North American and Asian strains. (C) The recombination of J-1 and 814 with North American and European strains.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CB8E328-F989-4FBE-A468-8F04B9912CFC}"/>
              </a:ext>
            </a:extLst>
          </p:cNvPr>
          <p:cNvSpPr txBox="1"/>
          <p:nvPr/>
        </p:nvSpPr>
        <p:spPr>
          <a:xfrm>
            <a:off x="181855" y="490569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8459EF0-3E3D-4932-8E8A-A9C3788EAB00}"/>
              </a:ext>
            </a:extLst>
          </p:cNvPr>
          <p:cNvSpPr txBox="1"/>
          <p:nvPr/>
        </p:nvSpPr>
        <p:spPr>
          <a:xfrm>
            <a:off x="123519" y="3582338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E345155-2410-4A68-A29A-9A4725AE5FA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859" y="678585"/>
            <a:ext cx="5844787" cy="300552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86F7DB6-0D83-4914-87E4-4B76CC59A41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418" y="3849902"/>
            <a:ext cx="5909227" cy="150101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2AD4D01-1CD8-4AF4-9BBF-93825877584C}"/>
              </a:ext>
            </a:extLst>
          </p:cNvPr>
          <p:cNvSpPr txBox="1"/>
          <p:nvPr/>
        </p:nvSpPr>
        <p:spPr>
          <a:xfrm>
            <a:off x="123519" y="5397055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0D2CD90B-D2A2-45DE-9A96-D552C096FDF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164" y="5766387"/>
            <a:ext cx="5989481" cy="1916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983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3</TotalTime>
  <Words>68</Words>
  <Application>Microsoft Office PowerPoint</Application>
  <PresentationFormat>A4 纸张(210x297 毫米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 Li</dc:creator>
  <cp:lastModifiedBy>likaihvri@163.com</cp:lastModifiedBy>
  <cp:revision>26</cp:revision>
  <dcterms:created xsi:type="dcterms:W3CDTF">2020-10-24T12:47:24Z</dcterms:created>
  <dcterms:modified xsi:type="dcterms:W3CDTF">2020-11-18T01:18:19Z</dcterms:modified>
</cp:coreProperties>
</file>